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348" r:id="rId2"/>
    <p:sldId id="347" r:id="rId3"/>
    <p:sldId id="345" r:id="rId4"/>
    <p:sldId id="34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70" d="100"/>
          <a:sy n="170" d="100"/>
        </p:scale>
        <p:origin x="234" y="-27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B97BD4-5469-4DF1-91E9-5D4C3BD18E97}" type="datetimeFigureOut">
              <a:rPr lang="en-IN" smtClean="0"/>
              <a:t>04-06-2023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BFCB83-E22F-43B4-8CD0-688C8A1C1DD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882105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8BFCB83-E22F-43B4-8CD0-688C8A1C1DD3}" type="slidenum">
              <a:rPr lang="en-IN" smtClean="0"/>
              <a:t>1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417913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8BFCB83-E22F-43B4-8CD0-688C8A1C1DD3}" type="slidenum">
              <a:rPr lang="en-IN" smtClean="0"/>
              <a:t>2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4542991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8BFCB83-E22F-43B4-8CD0-688C8A1C1DD3}" type="slidenum">
              <a:rPr lang="en-IN" smtClean="0"/>
              <a:t>3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395117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8BFCB83-E22F-43B4-8CD0-688C8A1C1DD3}" type="slidenum">
              <a:rPr lang="en-IN" smtClean="0"/>
              <a:t>4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634207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9DB18-DADA-49AD-98A2-7C5A07C5805D}" type="datetimeFigureOut">
              <a:rPr lang="en-IN" smtClean="0"/>
              <a:t>04-06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54AE3-FA2D-4992-9DF5-A1ADF0A0DD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664866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9DB18-DADA-49AD-98A2-7C5A07C5805D}" type="datetimeFigureOut">
              <a:rPr lang="en-IN" smtClean="0"/>
              <a:t>04-06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54AE3-FA2D-4992-9DF5-A1ADF0A0DD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015240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9DB18-DADA-49AD-98A2-7C5A07C5805D}" type="datetimeFigureOut">
              <a:rPr lang="en-IN" smtClean="0"/>
              <a:t>04-06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54AE3-FA2D-4992-9DF5-A1ADF0A0DD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188762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9DB18-DADA-49AD-98A2-7C5A07C5805D}" type="datetimeFigureOut">
              <a:rPr lang="en-IN" smtClean="0"/>
              <a:t>04-06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54AE3-FA2D-4992-9DF5-A1ADF0A0DD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38243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9DB18-DADA-49AD-98A2-7C5A07C5805D}" type="datetimeFigureOut">
              <a:rPr lang="en-IN" smtClean="0"/>
              <a:t>04-06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54AE3-FA2D-4992-9DF5-A1ADF0A0DD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182619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9DB18-DADA-49AD-98A2-7C5A07C5805D}" type="datetimeFigureOut">
              <a:rPr lang="en-IN" smtClean="0"/>
              <a:t>04-06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54AE3-FA2D-4992-9DF5-A1ADF0A0DD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789242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9DB18-DADA-49AD-98A2-7C5A07C5805D}" type="datetimeFigureOut">
              <a:rPr lang="en-IN" smtClean="0"/>
              <a:t>04-06-20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54AE3-FA2D-4992-9DF5-A1ADF0A0DD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68365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9DB18-DADA-49AD-98A2-7C5A07C5805D}" type="datetimeFigureOut">
              <a:rPr lang="en-IN" smtClean="0"/>
              <a:t>04-06-20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54AE3-FA2D-4992-9DF5-A1ADF0A0DD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345441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9DB18-DADA-49AD-98A2-7C5A07C5805D}" type="datetimeFigureOut">
              <a:rPr lang="en-IN" smtClean="0"/>
              <a:t>04-06-20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54AE3-FA2D-4992-9DF5-A1ADF0A0DD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16395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9DB18-DADA-49AD-98A2-7C5A07C5805D}" type="datetimeFigureOut">
              <a:rPr lang="en-IN" smtClean="0"/>
              <a:t>04-06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54AE3-FA2D-4992-9DF5-A1ADF0A0DD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144743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9DB18-DADA-49AD-98A2-7C5A07C5805D}" type="datetimeFigureOut">
              <a:rPr lang="en-IN" smtClean="0"/>
              <a:t>04-06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54AE3-FA2D-4992-9DF5-A1ADF0A0DD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4579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69DB18-DADA-49AD-98A2-7C5A07C5805D}" type="datetimeFigureOut">
              <a:rPr lang="en-IN" smtClean="0"/>
              <a:t>04-06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054AE3-FA2D-4992-9DF5-A1ADF0A0DDF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271070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hyperlink" Target="http://lmmd.ecust.edu.cn/admetsar1/" TargetMode="External"/><Relationship Id="rId3" Type="http://schemas.openxmlformats.org/officeDocument/2006/relationships/oleObject" Target="../embeddings/oleObject1.bin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hyperlink" Target="http://lmmd.ecust.edu.cn/admetsar1/" TargetMode="Externa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5" Type="http://schemas.openxmlformats.org/officeDocument/2006/relationships/image" Target="../media/image6.emf"/><Relationship Id="rId4" Type="http://schemas.openxmlformats.org/officeDocument/2006/relationships/oleObject" Target="../embeddings/oleObject2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hyperlink" Target="http://lmmd.ecust.edu.cn/admetsar1/" TargetMode="Externa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png"/><Relationship Id="rId5" Type="http://schemas.openxmlformats.org/officeDocument/2006/relationships/image" Target="../media/image8.emf"/><Relationship Id="rId4" Type="http://schemas.openxmlformats.org/officeDocument/2006/relationships/oleObject" Target="../embeddings/oleObject3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>
            <a:extLst>
              <a:ext uri="{FF2B5EF4-FFF2-40B4-BE49-F238E27FC236}">
                <a16:creationId xmlns:a16="http://schemas.microsoft.com/office/drawing/2014/main" id="{5F8CF39E-38A7-1779-FDFB-9F6E4A9A9987}"/>
              </a:ext>
            </a:extLst>
          </p:cNvPr>
          <p:cNvSpPr txBox="1"/>
          <p:nvPr/>
        </p:nvSpPr>
        <p:spPr>
          <a:xfrm>
            <a:off x="2019528" y="3858073"/>
            <a:ext cx="281414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800" b="1" i="1" u="sng" dirty="0">
                <a:latin typeface="Arial" panose="020B0604020202020204" pitchFamily="34" charset="0"/>
                <a:cs typeface="Arial" panose="020B0604020202020204" pitchFamily="34" charset="0"/>
              </a:rPr>
              <a:t>Interface residues of ATP (within 4Å) with TKD</a:t>
            </a:r>
          </a:p>
          <a:p>
            <a:pPr algn="just"/>
            <a:r>
              <a:rPr lang="en-IN" sz="800" dirty="0">
                <a:latin typeface="Arial" panose="020B0604020202020204" pitchFamily="34" charset="0"/>
                <a:cs typeface="Arial" panose="020B0604020202020204" pitchFamily="34" charset="0"/>
              </a:rPr>
              <a:t>- H-bond interactions: I-1025, D-1028, D-1046</a:t>
            </a:r>
          </a:p>
          <a:p>
            <a:pPr algn="just"/>
            <a:r>
              <a:rPr lang="en-IN" sz="800" dirty="0">
                <a:latin typeface="Arial" panose="020B0604020202020204" pitchFamily="34" charset="0"/>
                <a:cs typeface="Arial" panose="020B0604020202020204" pitchFamily="34" charset="0"/>
              </a:rPr>
              <a:t>- Non-contact interactions: E-885, I-888, L-889, I-892, V-899, C-1024, I-1026, R-1027, C-1045, G-1048, I-1053, Y-1059, L-1067, P-1068, Y-1082.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CA508A61-5017-005C-DE1F-395764CA98A7}"/>
              </a:ext>
            </a:extLst>
          </p:cNvPr>
          <p:cNvSpPr/>
          <p:nvPr/>
        </p:nvSpPr>
        <p:spPr>
          <a:xfrm>
            <a:off x="1976074" y="1846380"/>
            <a:ext cx="2880000" cy="252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48AD917-9512-5BF0-AA31-AD0380FED0F1}"/>
              </a:ext>
            </a:extLst>
          </p:cNvPr>
          <p:cNvSpPr txBox="1"/>
          <p:nvPr/>
        </p:nvSpPr>
        <p:spPr>
          <a:xfrm>
            <a:off x="2042639" y="3591472"/>
            <a:ext cx="18267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800" b="1" dirty="0">
                <a:latin typeface="Arial" panose="020B0604020202020204" pitchFamily="34" charset="0"/>
                <a:cs typeface="Arial" panose="020B0604020202020204" pitchFamily="34" charset="0"/>
              </a:rPr>
              <a:t>Binding affinity: -6.4kcal/mol</a:t>
            </a:r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3E6D4A66-C618-C9DC-8D56-57D39F8D1966}"/>
              </a:ext>
            </a:extLst>
          </p:cNvPr>
          <p:cNvSpPr/>
          <p:nvPr/>
        </p:nvSpPr>
        <p:spPr>
          <a:xfrm>
            <a:off x="3372059" y="3095070"/>
            <a:ext cx="295550" cy="288272"/>
          </a:xfrm>
          <a:prstGeom prst="ellipse">
            <a:avLst/>
          </a:prstGeom>
          <a:noFill/>
          <a:ln w="9525">
            <a:noFill/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sz="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F70CD241-CDAC-D18A-5C87-CC11925D4627}"/>
              </a:ext>
            </a:extLst>
          </p:cNvPr>
          <p:cNvSpPr/>
          <p:nvPr/>
        </p:nvSpPr>
        <p:spPr>
          <a:xfrm>
            <a:off x="3044423" y="3159798"/>
            <a:ext cx="181300" cy="197766"/>
          </a:xfrm>
          <a:prstGeom prst="ellipse">
            <a:avLst/>
          </a:prstGeom>
          <a:noFill/>
          <a:ln w="9525">
            <a:noFill/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sz="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07C2B5B3-6C2F-9CED-5B42-1914C1D3FDDB}"/>
              </a:ext>
            </a:extLst>
          </p:cNvPr>
          <p:cNvCxnSpPr>
            <a:cxnSpLocks/>
          </p:cNvCxnSpPr>
          <p:nvPr/>
        </p:nvCxnSpPr>
        <p:spPr>
          <a:xfrm>
            <a:off x="3216705" y="3325648"/>
            <a:ext cx="958740" cy="57694"/>
          </a:xfrm>
          <a:prstGeom prst="straightConnector1">
            <a:avLst/>
          </a:prstGeom>
          <a:ln w="6350">
            <a:noFill/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0B0A7494-8F60-E438-DDA7-3F79A03CCF90}"/>
              </a:ext>
            </a:extLst>
          </p:cNvPr>
          <p:cNvCxnSpPr>
            <a:cxnSpLocks/>
          </p:cNvCxnSpPr>
          <p:nvPr/>
        </p:nvCxnSpPr>
        <p:spPr>
          <a:xfrm flipV="1">
            <a:off x="3667609" y="2880167"/>
            <a:ext cx="550819" cy="288458"/>
          </a:xfrm>
          <a:prstGeom prst="straightConnector1">
            <a:avLst/>
          </a:prstGeom>
          <a:ln w="6350">
            <a:noFill/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Rectangle 43">
            <a:extLst>
              <a:ext uri="{FF2B5EF4-FFF2-40B4-BE49-F238E27FC236}">
                <a16:creationId xmlns:a16="http://schemas.microsoft.com/office/drawing/2014/main" id="{BA1D7237-2701-2BA2-1A99-A922C9520379}"/>
              </a:ext>
            </a:extLst>
          </p:cNvPr>
          <p:cNvSpPr/>
          <p:nvPr/>
        </p:nvSpPr>
        <p:spPr>
          <a:xfrm>
            <a:off x="2112311" y="2130656"/>
            <a:ext cx="2880000" cy="252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EBF8E868-E3AD-E2DA-7500-E8ED35DDDB08}"/>
              </a:ext>
            </a:extLst>
          </p:cNvPr>
          <p:cNvSpPr/>
          <p:nvPr/>
        </p:nvSpPr>
        <p:spPr>
          <a:xfrm>
            <a:off x="1979740" y="1810388"/>
            <a:ext cx="2880000" cy="284026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49B16A67-ABE6-D80B-D441-B83D65A01115}"/>
              </a:ext>
            </a:extLst>
          </p:cNvPr>
          <p:cNvSpPr txBox="1"/>
          <p:nvPr/>
        </p:nvSpPr>
        <p:spPr>
          <a:xfrm>
            <a:off x="1512328" y="613613"/>
            <a:ext cx="36973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Adenosine triphosphate (ATP)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61C98536-661B-16B1-4B74-291AB160B67A}"/>
              </a:ext>
            </a:extLst>
          </p:cNvPr>
          <p:cNvSpPr txBox="1"/>
          <p:nvPr/>
        </p:nvSpPr>
        <p:spPr>
          <a:xfrm>
            <a:off x="598375" y="4965028"/>
            <a:ext cx="578317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1: 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ocked pose of ATP with VEGFR-2 TKD domain and interacting residues.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ools: Molecular docking-UCSF Chimera 1.15. Image: 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yMol</a:t>
            </a:r>
            <a:r>
              <a:rPr lang="en-US" sz="1200" kern="10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3285DED-96C0-5D82-D610-76F1F75655AA}"/>
              </a:ext>
            </a:extLst>
          </p:cNvPr>
          <p:cNvSpPr txBox="1"/>
          <p:nvPr/>
        </p:nvSpPr>
        <p:spPr>
          <a:xfrm>
            <a:off x="6241772" y="7950"/>
            <a:ext cx="5963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F1</a:t>
            </a:r>
            <a:endParaRPr lang="en-I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8" name="Picture 47">
            <a:extLst>
              <a:ext uri="{FF2B5EF4-FFF2-40B4-BE49-F238E27FC236}">
                <a16:creationId xmlns:a16="http://schemas.microsoft.com/office/drawing/2014/main" id="{5AA7F1FD-18F7-7499-5346-E2A9D5CB84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33522" y="1896688"/>
            <a:ext cx="2772000" cy="15881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99413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6450AE8-F683-2C49-AD0B-001F2322AFA1}"/>
              </a:ext>
            </a:extLst>
          </p:cNvPr>
          <p:cNvSpPr/>
          <p:nvPr/>
        </p:nvSpPr>
        <p:spPr>
          <a:xfrm>
            <a:off x="1952125" y="1266967"/>
            <a:ext cx="2880000" cy="226393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00242BC-971A-DB64-DE1C-80C79BFE0D9B}"/>
              </a:ext>
            </a:extLst>
          </p:cNvPr>
          <p:cNvSpPr txBox="1"/>
          <p:nvPr/>
        </p:nvSpPr>
        <p:spPr>
          <a:xfrm>
            <a:off x="1328530" y="980188"/>
            <a:ext cx="4160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2" name="Object 41">
            <a:extLst>
              <a:ext uri="{FF2B5EF4-FFF2-40B4-BE49-F238E27FC236}">
                <a16:creationId xmlns:a16="http://schemas.microsoft.com/office/drawing/2014/main" id="{2CB8667B-1FE9-E0C4-959C-4A0C5D552F5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997843" y="1473955"/>
          <a:ext cx="2788169" cy="20501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" imgW="3495985" imgH="2569511" progId="ChemDraw.Document.6.0">
                  <p:embed/>
                </p:oleObj>
              </mc:Choice>
              <mc:Fallback>
                <p:oleObj r:id="rId3" imgW="3495985" imgH="2569511" progId="ChemDraw.Document.6.0">
                  <p:embed/>
                  <p:pic>
                    <p:nvPicPr>
                      <p:cNvPr id="42" name="Object 41">
                        <a:extLst>
                          <a:ext uri="{FF2B5EF4-FFF2-40B4-BE49-F238E27FC236}">
                            <a16:creationId xmlns:a16="http://schemas.microsoft.com/office/drawing/2014/main" id="{2CB8667B-1FE9-E0C4-959C-4A0C5D552F52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997843" y="1473955"/>
                        <a:ext cx="2788169" cy="2050124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AAA1862B-E284-7CEA-8A84-2CDAB8BA6025}"/>
              </a:ext>
            </a:extLst>
          </p:cNvPr>
          <p:cNvSpPr txBox="1"/>
          <p:nvPr/>
        </p:nvSpPr>
        <p:spPr>
          <a:xfrm>
            <a:off x="1939132" y="3544358"/>
            <a:ext cx="2879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BB+: </a:t>
            </a:r>
            <a:r>
              <a:rPr lang="en-IN" sz="1200" b="0" i="0" kern="1200" dirty="0">
                <a:solidFill>
                  <a:schemeClr val="dk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.7839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B0867887-64AE-4C05-DBF6-5AF35380BA11}"/>
              </a:ext>
            </a:extLst>
          </p:cNvPr>
          <p:cNvGrpSpPr/>
          <p:nvPr/>
        </p:nvGrpSpPr>
        <p:grpSpPr>
          <a:xfrm>
            <a:off x="1976074" y="4673907"/>
            <a:ext cx="3016237" cy="2840268"/>
            <a:chOff x="3432188" y="4092518"/>
            <a:chExt cx="3016237" cy="2840268"/>
          </a:xfrm>
        </p:grpSpPr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5F8CF39E-38A7-1779-FDFB-9F6E4A9A9987}"/>
                </a:ext>
              </a:extLst>
            </p:cNvPr>
            <p:cNvSpPr txBox="1"/>
            <p:nvPr/>
          </p:nvSpPr>
          <p:spPr>
            <a:xfrm>
              <a:off x="3475642" y="6140203"/>
              <a:ext cx="2814143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IN" sz="800" b="1" i="1" u="sng" dirty="0">
                  <a:latin typeface="Arial" panose="020B0604020202020204" pitchFamily="34" charset="0"/>
                  <a:cs typeface="Arial" panose="020B0604020202020204" pitchFamily="34" charset="0"/>
                </a:rPr>
                <a:t>Interface residues of </a:t>
              </a:r>
              <a:r>
                <a:rPr lang="en-IN" sz="800" b="1" i="1" u="sng" dirty="0" err="1">
                  <a:latin typeface="Arial" panose="020B0604020202020204" pitchFamily="34" charset="0"/>
                  <a:cs typeface="Arial" panose="020B0604020202020204" pitchFamily="34" charset="0"/>
                </a:rPr>
                <a:t>Nimbolide</a:t>
              </a:r>
              <a:r>
                <a:rPr lang="en-IN" sz="800" b="1" i="1" u="sng" dirty="0">
                  <a:latin typeface="Arial" panose="020B0604020202020204" pitchFamily="34" charset="0"/>
                  <a:cs typeface="Arial" panose="020B0604020202020204" pitchFamily="34" charset="0"/>
                </a:rPr>
                <a:t> (within 4Å) at ATP binding site on TKD</a:t>
              </a:r>
            </a:p>
            <a:p>
              <a:pPr algn="just"/>
              <a:r>
                <a:rPr lang="en-IN" sz="800" dirty="0">
                  <a:latin typeface="Arial" panose="020B0604020202020204" pitchFamily="34" charset="0"/>
                  <a:cs typeface="Arial" panose="020B0604020202020204" pitchFamily="34" charset="0"/>
                </a:rPr>
                <a:t>- H-bond interactions: D-1052, D-1056</a:t>
              </a:r>
            </a:p>
            <a:p>
              <a:pPr algn="just"/>
              <a:r>
                <a:rPr lang="en-IN" sz="800" dirty="0">
                  <a:latin typeface="Arial" panose="020B0604020202020204" pitchFamily="34" charset="0"/>
                  <a:cs typeface="Arial" panose="020B0604020202020204" pitchFamily="34" charset="0"/>
                </a:rPr>
                <a:t>- Non-contact interactions: G-841, R-842, N-923, T-926, R-929, R-1032, A-1050, R-1051, K-1055, P-1057</a:t>
              </a:r>
            </a:p>
          </p:txBody>
        </p: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F9F84438-CD6A-6B28-7606-11EE7F751307}"/>
                </a:ext>
              </a:extLst>
            </p:cNvPr>
            <p:cNvGrpSpPr/>
            <p:nvPr/>
          </p:nvGrpSpPr>
          <p:grpSpPr>
            <a:xfrm>
              <a:off x="3532976" y="4235923"/>
              <a:ext cx="2714004" cy="1620000"/>
              <a:chOff x="582740" y="1286791"/>
              <a:chExt cx="8467367" cy="4680000"/>
            </a:xfrm>
          </p:grpSpPr>
          <p:pic>
            <p:nvPicPr>
              <p:cNvPr id="46" name="Picture 45">
                <a:extLst>
                  <a:ext uri="{FF2B5EF4-FFF2-40B4-BE49-F238E27FC236}">
                    <a16:creationId xmlns:a16="http://schemas.microsoft.com/office/drawing/2014/main" id="{44AB32DF-1DF4-41CE-BCFD-F52337A82A4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161" r="7747"/>
              <a:stretch/>
            </p:blipFill>
            <p:spPr>
              <a:xfrm>
                <a:off x="6587908" y="1473220"/>
                <a:ext cx="2219143" cy="1980000"/>
              </a:xfrm>
              <a:prstGeom prst="ellipse">
                <a:avLst/>
              </a:prstGeom>
              <a:ln>
                <a:noFill/>
              </a:ln>
              <a:effectLst>
                <a:softEdge rad="112500"/>
              </a:effectLst>
            </p:spPr>
          </p:pic>
          <p:pic>
            <p:nvPicPr>
              <p:cNvPr id="57" name="Picture 56">
                <a:extLst>
                  <a:ext uri="{FF2B5EF4-FFF2-40B4-BE49-F238E27FC236}">
                    <a16:creationId xmlns:a16="http://schemas.microsoft.com/office/drawing/2014/main" id="{4970CB06-30C8-9F66-01CE-DC68BFDDC4A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149" r="8046"/>
              <a:stretch/>
            </p:blipFill>
            <p:spPr>
              <a:xfrm>
                <a:off x="6709772" y="3620591"/>
                <a:ext cx="2233111" cy="1980000"/>
              </a:xfrm>
              <a:prstGeom prst="ellipse">
                <a:avLst/>
              </a:prstGeom>
              <a:ln>
                <a:noFill/>
              </a:ln>
              <a:effectLst>
                <a:softEdge rad="112500"/>
              </a:effectLst>
            </p:spPr>
          </p:pic>
          <p:pic>
            <p:nvPicPr>
              <p:cNvPr id="58" name="Picture 57">
                <a:extLst>
                  <a:ext uri="{FF2B5EF4-FFF2-40B4-BE49-F238E27FC236}">
                    <a16:creationId xmlns:a16="http://schemas.microsoft.com/office/drawing/2014/main" id="{781A7051-1470-FDB3-DE3A-6B5DF8740BA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82740" y="1286791"/>
                <a:ext cx="5809979" cy="4680000"/>
              </a:xfrm>
              <a:prstGeom prst="rect">
                <a:avLst/>
              </a:prstGeom>
            </p:spPr>
          </p:pic>
          <p:sp>
            <p:nvSpPr>
              <p:cNvPr id="59" name="Oval 58">
                <a:extLst>
                  <a:ext uri="{FF2B5EF4-FFF2-40B4-BE49-F238E27FC236}">
                    <a16:creationId xmlns:a16="http://schemas.microsoft.com/office/drawing/2014/main" id="{1A2A1A6E-9CB2-C2BB-A447-079595A15AC1}"/>
                  </a:ext>
                </a:extLst>
              </p:cNvPr>
              <p:cNvSpPr/>
              <p:nvPr/>
            </p:nvSpPr>
            <p:spPr>
              <a:xfrm>
                <a:off x="4198556" y="3762572"/>
                <a:ext cx="922081" cy="832786"/>
              </a:xfrm>
              <a:prstGeom prst="ellipse">
                <a:avLst/>
              </a:prstGeom>
              <a:noFill/>
              <a:ln w="9525">
                <a:solidFill>
                  <a:srgbClr val="002060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Oval 59">
                <a:extLst>
                  <a:ext uri="{FF2B5EF4-FFF2-40B4-BE49-F238E27FC236}">
                    <a16:creationId xmlns:a16="http://schemas.microsoft.com/office/drawing/2014/main" id="{3A57DABE-8B89-C16F-DEF8-70A71AA392C3}"/>
                  </a:ext>
                </a:extLst>
              </p:cNvPr>
              <p:cNvSpPr/>
              <p:nvPr/>
            </p:nvSpPr>
            <p:spPr>
              <a:xfrm>
                <a:off x="3176371" y="3949565"/>
                <a:ext cx="565635" cy="571323"/>
              </a:xfrm>
              <a:prstGeom prst="ellipse">
                <a:avLst/>
              </a:prstGeom>
              <a:noFill/>
              <a:ln w="9525">
                <a:solidFill>
                  <a:srgbClr val="0070C0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1" name="Straight Arrow Connector 60">
                <a:extLst>
                  <a:ext uri="{FF2B5EF4-FFF2-40B4-BE49-F238E27FC236}">
                    <a16:creationId xmlns:a16="http://schemas.microsoft.com/office/drawing/2014/main" id="{72CACFE5-13E5-0A83-553A-AAA53F0F9B8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13870" y="4428687"/>
                <a:ext cx="2991155" cy="166671"/>
              </a:xfrm>
              <a:prstGeom prst="straightConnector1">
                <a:avLst/>
              </a:prstGeom>
              <a:ln w="6350">
                <a:solidFill>
                  <a:srgbClr val="0070C0"/>
                </a:solidFill>
                <a:prstDash val="lgDash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Straight Arrow Connector 61">
                <a:extLst>
                  <a:ext uri="{FF2B5EF4-FFF2-40B4-BE49-F238E27FC236}">
                    <a16:creationId xmlns:a16="http://schemas.microsoft.com/office/drawing/2014/main" id="{F67A17DE-1033-A724-12DF-3E955FD31DE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120637" y="3141742"/>
                <a:ext cx="1718490" cy="833323"/>
              </a:xfrm>
              <a:prstGeom prst="straightConnector1">
                <a:avLst/>
              </a:prstGeom>
              <a:ln w="6350">
                <a:solidFill>
                  <a:srgbClr val="002060"/>
                </a:solidFill>
                <a:prstDash val="lgDash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Oval 62">
                <a:extLst>
                  <a:ext uri="{FF2B5EF4-FFF2-40B4-BE49-F238E27FC236}">
                    <a16:creationId xmlns:a16="http://schemas.microsoft.com/office/drawing/2014/main" id="{F8873C34-64B4-304E-E959-02D6EADF7BE0}"/>
                  </a:ext>
                </a:extLst>
              </p:cNvPr>
              <p:cNvSpPr/>
              <p:nvPr/>
            </p:nvSpPr>
            <p:spPr>
              <a:xfrm>
                <a:off x="6733161" y="3539695"/>
                <a:ext cx="2111247" cy="2139462"/>
              </a:xfrm>
              <a:prstGeom prst="ellipse">
                <a:avLst/>
              </a:prstGeom>
              <a:noFill/>
              <a:ln w="12700">
                <a:solidFill>
                  <a:srgbClr val="0070C0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400">
                  <a:noFill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Oval 63">
                <a:extLst>
                  <a:ext uri="{FF2B5EF4-FFF2-40B4-BE49-F238E27FC236}">
                    <a16:creationId xmlns:a16="http://schemas.microsoft.com/office/drawing/2014/main" id="{4F9B147D-9644-5E08-2BD3-A37EF5557F00}"/>
                  </a:ext>
                </a:extLst>
              </p:cNvPr>
              <p:cNvSpPr/>
              <p:nvPr/>
            </p:nvSpPr>
            <p:spPr>
              <a:xfrm>
                <a:off x="6611297" y="1397752"/>
                <a:ext cx="2111247" cy="2139462"/>
              </a:xfrm>
              <a:prstGeom prst="ellipse">
                <a:avLst/>
              </a:prstGeom>
              <a:noFill/>
              <a:ln w="12700">
                <a:solidFill>
                  <a:srgbClr val="002060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400">
                  <a:noFill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4773DD36-D865-121A-3F2F-5D08F765EC2C}"/>
                  </a:ext>
                </a:extLst>
              </p:cNvPr>
              <p:cNvSpPr txBox="1"/>
              <p:nvPr/>
            </p:nvSpPr>
            <p:spPr>
              <a:xfrm>
                <a:off x="7363862" y="2069827"/>
                <a:ext cx="1372623" cy="4445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N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SP-1052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A682D03C-56C4-E21E-3FAD-6FA3F2D4E42F}"/>
                  </a:ext>
                </a:extLst>
              </p:cNvPr>
              <p:cNvSpPr txBox="1"/>
              <p:nvPr/>
            </p:nvSpPr>
            <p:spPr>
              <a:xfrm>
                <a:off x="7378501" y="2296755"/>
                <a:ext cx="1148525" cy="4445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.5Å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E4B4CB07-85BF-9FF8-0112-7A434BCC0C49}"/>
                  </a:ext>
                </a:extLst>
              </p:cNvPr>
              <p:cNvSpPr txBox="1"/>
              <p:nvPr/>
            </p:nvSpPr>
            <p:spPr>
              <a:xfrm>
                <a:off x="7669897" y="4638486"/>
                <a:ext cx="1380210" cy="4445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SP-1056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0DB79F25-075D-9208-9AE1-5CE51307C72F}"/>
                  </a:ext>
                </a:extLst>
              </p:cNvPr>
              <p:cNvSpPr txBox="1"/>
              <p:nvPr/>
            </p:nvSpPr>
            <p:spPr>
              <a:xfrm>
                <a:off x="7634025" y="4249124"/>
                <a:ext cx="1169078" cy="4445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8Å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76E55512-0442-DC3A-730D-CD5337379208}"/>
                  </a:ext>
                </a:extLst>
              </p:cNvPr>
              <p:cNvSpPr txBox="1"/>
              <p:nvPr/>
            </p:nvSpPr>
            <p:spPr>
              <a:xfrm>
                <a:off x="6860429" y="1759760"/>
                <a:ext cx="1148522" cy="4445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2Å</a:t>
                </a:r>
              </a:p>
            </p:txBody>
          </p:sp>
        </p:grp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CA508A61-5017-005C-DE1F-395764CA98A7}"/>
                </a:ext>
              </a:extLst>
            </p:cNvPr>
            <p:cNvSpPr/>
            <p:nvPr/>
          </p:nvSpPr>
          <p:spPr>
            <a:xfrm>
              <a:off x="3432188" y="4128510"/>
              <a:ext cx="2880000" cy="252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F48AD917-9512-5BF0-AA31-AD0380FED0F1}"/>
                </a:ext>
              </a:extLst>
            </p:cNvPr>
            <p:cNvSpPr txBox="1"/>
            <p:nvPr/>
          </p:nvSpPr>
          <p:spPr>
            <a:xfrm>
              <a:off x="3498753" y="5873602"/>
              <a:ext cx="182679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inding affinity: -6.7kcal/mol</a:t>
              </a:r>
            </a:p>
          </p:txBody>
        </p:sp>
        <p:sp>
          <p:nvSpPr>
            <p:cNvPr id="35" name="Oval 34">
              <a:extLst>
                <a:ext uri="{FF2B5EF4-FFF2-40B4-BE49-F238E27FC236}">
                  <a16:creationId xmlns:a16="http://schemas.microsoft.com/office/drawing/2014/main" id="{3E6D4A66-C618-C9DC-8D56-57D39F8D1966}"/>
                </a:ext>
              </a:extLst>
            </p:cNvPr>
            <p:cNvSpPr/>
            <p:nvPr/>
          </p:nvSpPr>
          <p:spPr>
            <a:xfrm>
              <a:off x="4828173" y="5377200"/>
              <a:ext cx="295550" cy="288272"/>
            </a:xfrm>
            <a:prstGeom prst="ellipse">
              <a:avLst/>
            </a:prstGeom>
            <a:noFill/>
            <a:ln w="9525">
              <a:noFill/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Oval 35">
              <a:extLst>
                <a:ext uri="{FF2B5EF4-FFF2-40B4-BE49-F238E27FC236}">
                  <a16:creationId xmlns:a16="http://schemas.microsoft.com/office/drawing/2014/main" id="{F70CD241-CDAC-D18A-5C87-CC11925D4627}"/>
                </a:ext>
              </a:extLst>
            </p:cNvPr>
            <p:cNvSpPr/>
            <p:nvPr/>
          </p:nvSpPr>
          <p:spPr>
            <a:xfrm>
              <a:off x="4500537" y="5441928"/>
              <a:ext cx="181300" cy="197766"/>
            </a:xfrm>
            <a:prstGeom prst="ellipse">
              <a:avLst/>
            </a:prstGeom>
            <a:noFill/>
            <a:ln w="9525">
              <a:noFill/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Straight Arrow Connector 36">
              <a:extLst>
                <a:ext uri="{FF2B5EF4-FFF2-40B4-BE49-F238E27FC236}">
                  <a16:creationId xmlns:a16="http://schemas.microsoft.com/office/drawing/2014/main" id="{07C2B5B3-6C2F-9CED-5B42-1914C1D3FDDB}"/>
                </a:ext>
              </a:extLst>
            </p:cNvPr>
            <p:cNvCxnSpPr>
              <a:cxnSpLocks/>
            </p:cNvCxnSpPr>
            <p:nvPr/>
          </p:nvCxnSpPr>
          <p:spPr>
            <a:xfrm>
              <a:off x="4672819" y="5607778"/>
              <a:ext cx="958740" cy="57694"/>
            </a:xfrm>
            <a:prstGeom prst="straightConnector1">
              <a:avLst/>
            </a:prstGeom>
            <a:ln w="6350">
              <a:noFill/>
              <a:prstDash val="lg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0B0A7494-8F60-E438-DDA7-3F79A03CCF9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123723" y="5162297"/>
              <a:ext cx="550819" cy="288458"/>
            </a:xfrm>
            <a:prstGeom prst="straightConnector1">
              <a:avLst/>
            </a:prstGeom>
            <a:ln w="6350">
              <a:noFill/>
              <a:prstDash val="lg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BA1D7237-2701-2BA2-1A99-A922C9520379}"/>
                </a:ext>
              </a:extLst>
            </p:cNvPr>
            <p:cNvSpPr/>
            <p:nvPr/>
          </p:nvSpPr>
          <p:spPr>
            <a:xfrm>
              <a:off x="3568425" y="4412786"/>
              <a:ext cx="2880000" cy="2520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EBF8E868-E3AD-E2DA-7500-E8ED35DDDB08}"/>
                </a:ext>
              </a:extLst>
            </p:cNvPr>
            <p:cNvSpPr/>
            <p:nvPr/>
          </p:nvSpPr>
          <p:spPr>
            <a:xfrm>
              <a:off x="3435854" y="4092518"/>
              <a:ext cx="2880000" cy="2840268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0" name="TextBox 69">
            <a:extLst>
              <a:ext uri="{FF2B5EF4-FFF2-40B4-BE49-F238E27FC236}">
                <a16:creationId xmlns:a16="http://schemas.microsoft.com/office/drawing/2014/main" id="{49B16A67-ABE6-D80B-D441-B83D65A01115}"/>
              </a:ext>
            </a:extLst>
          </p:cNvPr>
          <p:cNvSpPr txBox="1"/>
          <p:nvPr/>
        </p:nvSpPr>
        <p:spPr>
          <a:xfrm>
            <a:off x="2125942" y="613613"/>
            <a:ext cx="2472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Nimbolide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(NBL)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4A66A9E8-8F3B-9634-2A93-75BE04599BF8}"/>
              </a:ext>
            </a:extLst>
          </p:cNvPr>
          <p:cNvSpPr txBox="1"/>
          <p:nvPr/>
        </p:nvSpPr>
        <p:spPr>
          <a:xfrm>
            <a:off x="1324518" y="4332996"/>
            <a:ext cx="4160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61C98536-661B-16B1-4B74-291AB160B67A}"/>
              </a:ext>
            </a:extLst>
          </p:cNvPr>
          <p:cNvSpPr txBox="1"/>
          <p:nvPr/>
        </p:nvSpPr>
        <p:spPr>
          <a:xfrm>
            <a:off x="598375" y="7828547"/>
            <a:ext cx="578317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2: </a:t>
            </a:r>
            <a:r>
              <a:rPr lang="en-US" sz="1200" b="1" i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silico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valuation of NBL for GBM therapeutics. (A)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D chemical structure drawn using 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emDraw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ith BBB permeability probability score;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B)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ocked pose of NBL with VEGFR-2 TKD domain and interacting residues. Tools: BBB permeability by 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metSAR</a:t>
            </a:r>
            <a:r>
              <a:rPr lang="en-US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US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hlinkClick r:id="rId8"/>
              </a:rPr>
              <a:t>http://lmmd.ecust.edu.cn/admetsar1/</a:t>
            </a:r>
            <a:r>
              <a:rPr lang="en-US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molecular docking UCSF Chimera 1.15. Image: 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yMol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3285DED-96C0-5D82-D610-76F1F75655AA}"/>
              </a:ext>
            </a:extLst>
          </p:cNvPr>
          <p:cNvSpPr txBox="1"/>
          <p:nvPr/>
        </p:nvSpPr>
        <p:spPr>
          <a:xfrm>
            <a:off x="6241772" y="7950"/>
            <a:ext cx="5963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F2</a:t>
            </a:r>
            <a:endParaRPr lang="en-I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51175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6450AE8-F683-2C49-AD0B-001F2322AFA1}"/>
              </a:ext>
            </a:extLst>
          </p:cNvPr>
          <p:cNvSpPr/>
          <p:nvPr/>
        </p:nvSpPr>
        <p:spPr>
          <a:xfrm>
            <a:off x="1952125" y="1266967"/>
            <a:ext cx="2880000" cy="226393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00242BC-971A-DB64-DE1C-80C79BFE0D9B}"/>
              </a:ext>
            </a:extLst>
          </p:cNvPr>
          <p:cNvSpPr txBox="1"/>
          <p:nvPr/>
        </p:nvSpPr>
        <p:spPr>
          <a:xfrm>
            <a:off x="1328530" y="980188"/>
            <a:ext cx="4160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AA1862B-E284-7CEA-8A84-2CDAB8BA6025}"/>
              </a:ext>
            </a:extLst>
          </p:cNvPr>
          <p:cNvSpPr txBox="1"/>
          <p:nvPr/>
        </p:nvSpPr>
        <p:spPr>
          <a:xfrm>
            <a:off x="1939132" y="3544358"/>
            <a:ext cx="2879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BB+: 0.982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F8CF39E-38A7-1779-FDFB-9F6E4A9A9987}"/>
              </a:ext>
            </a:extLst>
          </p:cNvPr>
          <p:cNvSpPr txBox="1"/>
          <p:nvPr/>
        </p:nvSpPr>
        <p:spPr>
          <a:xfrm>
            <a:off x="2019528" y="6721592"/>
            <a:ext cx="281414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800" b="1" i="1" u="sng" dirty="0">
                <a:latin typeface="Arial" panose="020B0604020202020204" pitchFamily="34" charset="0"/>
                <a:cs typeface="Arial" panose="020B0604020202020204" pitchFamily="34" charset="0"/>
              </a:rPr>
              <a:t>Interface residues of Trans-chalcone (within 4Å) at ATP binding site on TKD</a:t>
            </a:r>
          </a:p>
          <a:p>
            <a:pPr algn="just"/>
            <a:r>
              <a:rPr lang="en-IN" sz="800" dirty="0">
                <a:latin typeface="Arial" panose="020B0604020202020204" pitchFamily="34" charset="0"/>
                <a:cs typeface="Arial" panose="020B0604020202020204" pitchFamily="34" charset="0"/>
              </a:rPr>
              <a:t>- H-bond interactions: None</a:t>
            </a:r>
          </a:p>
          <a:p>
            <a:pPr algn="just"/>
            <a:r>
              <a:rPr lang="en-IN" sz="800" dirty="0">
                <a:latin typeface="Arial" panose="020B0604020202020204" pitchFamily="34" charset="0"/>
                <a:cs typeface="Arial" panose="020B0604020202020204" pitchFamily="34" charset="0"/>
              </a:rPr>
              <a:t>- Non-contact interactions: V848, A866, K868, E885, I888, L889, V899, V914, V916, L1035, C1045, D1046, F1047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CA508A61-5017-005C-DE1F-395764CA98A7}"/>
              </a:ext>
            </a:extLst>
          </p:cNvPr>
          <p:cNvSpPr/>
          <p:nvPr/>
        </p:nvSpPr>
        <p:spPr>
          <a:xfrm>
            <a:off x="1976074" y="4709899"/>
            <a:ext cx="2880000" cy="252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48AD917-9512-5BF0-AA31-AD0380FED0F1}"/>
              </a:ext>
            </a:extLst>
          </p:cNvPr>
          <p:cNvSpPr txBox="1"/>
          <p:nvPr/>
        </p:nvSpPr>
        <p:spPr>
          <a:xfrm>
            <a:off x="2042639" y="6454991"/>
            <a:ext cx="18267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800" b="1" dirty="0">
                <a:latin typeface="Arial" panose="020B0604020202020204" pitchFamily="34" charset="0"/>
                <a:cs typeface="Arial" panose="020B0604020202020204" pitchFamily="34" charset="0"/>
              </a:rPr>
              <a:t>Binding affinity: -8.6kcal/mol</a:t>
            </a:r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3E6D4A66-C618-C9DC-8D56-57D39F8D1966}"/>
              </a:ext>
            </a:extLst>
          </p:cNvPr>
          <p:cNvSpPr/>
          <p:nvPr/>
        </p:nvSpPr>
        <p:spPr>
          <a:xfrm>
            <a:off x="3372059" y="5958589"/>
            <a:ext cx="295550" cy="288272"/>
          </a:xfrm>
          <a:prstGeom prst="ellipse">
            <a:avLst/>
          </a:prstGeom>
          <a:noFill/>
          <a:ln w="9525">
            <a:noFill/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sz="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F70CD241-CDAC-D18A-5C87-CC11925D4627}"/>
              </a:ext>
            </a:extLst>
          </p:cNvPr>
          <p:cNvSpPr/>
          <p:nvPr/>
        </p:nvSpPr>
        <p:spPr>
          <a:xfrm>
            <a:off x="3044423" y="6023317"/>
            <a:ext cx="181300" cy="197766"/>
          </a:xfrm>
          <a:prstGeom prst="ellipse">
            <a:avLst/>
          </a:prstGeom>
          <a:noFill/>
          <a:ln w="9525">
            <a:noFill/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sz="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07C2B5B3-6C2F-9CED-5B42-1914C1D3FDDB}"/>
              </a:ext>
            </a:extLst>
          </p:cNvPr>
          <p:cNvCxnSpPr>
            <a:cxnSpLocks/>
          </p:cNvCxnSpPr>
          <p:nvPr/>
        </p:nvCxnSpPr>
        <p:spPr>
          <a:xfrm>
            <a:off x="3216705" y="6189167"/>
            <a:ext cx="958740" cy="57694"/>
          </a:xfrm>
          <a:prstGeom prst="straightConnector1">
            <a:avLst/>
          </a:prstGeom>
          <a:ln w="6350">
            <a:noFill/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0B0A7494-8F60-E438-DDA7-3F79A03CCF90}"/>
              </a:ext>
            </a:extLst>
          </p:cNvPr>
          <p:cNvCxnSpPr>
            <a:cxnSpLocks/>
          </p:cNvCxnSpPr>
          <p:nvPr/>
        </p:nvCxnSpPr>
        <p:spPr>
          <a:xfrm flipV="1">
            <a:off x="3667609" y="5743686"/>
            <a:ext cx="550819" cy="288458"/>
          </a:xfrm>
          <a:prstGeom prst="straightConnector1">
            <a:avLst/>
          </a:prstGeom>
          <a:ln w="6350">
            <a:noFill/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Rectangle 43">
            <a:extLst>
              <a:ext uri="{FF2B5EF4-FFF2-40B4-BE49-F238E27FC236}">
                <a16:creationId xmlns:a16="http://schemas.microsoft.com/office/drawing/2014/main" id="{BA1D7237-2701-2BA2-1A99-A922C9520379}"/>
              </a:ext>
            </a:extLst>
          </p:cNvPr>
          <p:cNvSpPr/>
          <p:nvPr/>
        </p:nvSpPr>
        <p:spPr>
          <a:xfrm>
            <a:off x="2112311" y="4994175"/>
            <a:ext cx="2880000" cy="252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EBF8E868-E3AD-E2DA-7500-E8ED35DDDB08}"/>
              </a:ext>
            </a:extLst>
          </p:cNvPr>
          <p:cNvSpPr/>
          <p:nvPr/>
        </p:nvSpPr>
        <p:spPr>
          <a:xfrm>
            <a:off x="1979740" y="4673907"/>
            <a:ext cx="2880000" cy="284026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49B16A67-ABE6-D80B-D441-B83D65A01115}"/>
              </a:ext>
            </a:extLst>
          </p:cNvPr>
          <p:cNvSpPr txBox="1"/>
          <p:nvPr/>
        </p:nvSpPr>
        <p:spPr>
          <a:xfrm>
            <a:off x="2125942" y="613613"/>
            <a:ext cx="2472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rans-chalcone (TC)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4A66A9E8-8F3B-9634-2A93-75BE04599BF8}"/>
              </a:ext>
            </a:extLst>
          </p:cNvPr>
          <p:cNvSpPr txBox="1"/>
          <p:nvPr/>
        </p:nvSpPr>
        <p:spPr>
          <a:xfrm>
            <a:off x="1324518" y="4332996"/>
            <a:ext cx="4160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61C98536-661B-16B1-4B74-291AB160B67A}"/>
              </a:ext>
            </a:extLst>
          </p:cNvPr>
          <p:cNvSpPr txBox="1"/>
          <p:nvPr/>
        </p:nvSpPr>
        <p:spPr>
          <a:xfrm>
            <a:off x="598375" y="7828547"/>
            <a:ext cx="578317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3: </a:t>
            </a:r>
            <a:r>
              <a:rPr lang="en-US" sz="1200" b="1" i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silico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valuation of </a:t>
            </a:r>
            <a:r>
              <a:rPr lang="en-US" sz="12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C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or GBM therapeutics. (A)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D chemical structure drawn using 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emDraw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ith BBB permeability probability score;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B)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ocked pose of TC with VEGFR-2 TKD domain and interacting residues. Tools: BBB permeability by 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metSAR</a:t>
            </a:r>
            <a:r>
              <a:rPr lang="en-US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US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hlinkClick r:id="rId3"/>
              </a:rPr>
              <a:t>http://lmmd.ecust.edu.cn/admetsar1/</a:t>
            </a:r>
            <a:r>
              <a:rPr lang="en-US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molecular docking UCSF Chimera 1.15. Image: 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yMol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6FC5E30D-0807-2DDE-0BDB-A3B7D822AA4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92747582"/>
              </p:ext>
            </p:extLst>
          </p:nvPr>
        </p:nvGraphicFramePr>
        <p:xfrm>
          <a:off x="2667458" y="1293527"/>
          <a:ext cx="1512000" cy="21891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1749694" imgH="2536252" progId="ChemDraw.Document.6.0">
                  <p:embed/>
                </p:oleObj>
              </mc:Choice>
              <mc:Fallback>
                <p:oleObj r:id="rId4" imgW="1749694" imgH="2536252" progId="ChemDraw.Document.6.0">
                  <p:embed/>
                  <p:pic>
                    <p:nvPicPr>
                      <p:cNvPr id="41" name="Object 40">
                        <a:extLst>
                          <a:ext uri="{FF2B5EF4-FFF2-40B4-BE49-F238E27FC236}">
                            <a16:creationId xmlns:a16="http://schemas.microsoft.com/office/drawing/2014/main" id="{99680D5D-DAFA-E731-A966-3DDA3DEC3DD9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67458" y="1293527"/>
                        <a:ext cx="1512000" cy="2189161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A19BD1D3-4256-A192-9D6D-E64E0588C8B9}"/>
              </a:ext>
            </a:extLst>
          </p:cNvPr>
          <p:cNvSpPr txBox="1"/>
          <p:nvPr/>
        </p:nvSpPr>
        <p:spPr>
          <a:xfrm>
            <a:off x="6241772" y="7950"/>
            <a:ext cx="5963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F3</a:t>
            </a:r>
            <a:endParaRPr lang="en-I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5855940F-75F9-2623-EAE1-CD6B5339F2D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29707"/>
          <a:stretch/>
        </p:blipFill>
        <p:spPr>
          <a:xfrm>
            <a:off x="2413830" y="4781497"/>
            <a:ext cx="2016000" cy="1641287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0708339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6450AE8-F683-2C49-AD0B-001F2322AFA1}"/>
              </a:ext>
            </a:extLst>
          </p:cNvPr>
          <p:cNvSpPr/>
          <p:nvPr/>
        </p:nvSpPr>
        <p:spPr>
          <a:xfrm>
            <a:off x="1952125" y="1266967"/>
            <a:ext cx="2880000" cy="226393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00242BC-971A-DB64-DE1C-80C79BFE0D9B}"/>
              </a:ext>
            </a:extLst>
          </p:cNvPr>
          <p:cNvSpPr txBox="1"/>
          <p:nvPr/>
        </p:nvSpPr>
        <p:spPr>
          <a:xfrm>
            <a:off x="1328530" y="980188"/>
            <a:ext cx="4160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AA1862B-E284-7CEA-8A84-2CDAB8BA6025}"/>
              </a:ext>
            </a:extLst>
          </p:cNvPr>
          <p:cNvSpPr txBox="1"/>
          <p:nvPr/>
        </p:nvSpPr>
        <p:spPr>
          <a:xfrm>
            <a:off x="1939132" y="3544358"/>
            <a:ext cx="2879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BB+: 0.9964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F8CF39E-38A7-1779-FDFB-9F6E4A9A9987}"/>
              </a:ext>
            </a:extLst>
          </p:cNvPr>
          <p:cNvSpPr txBox="1"/>
          <p:nvPr/>
        </p:nvSpPr>
        <p:spPr>
          <a:xfrm>
            <a:off x="2019528" y="6602327"/>
            <a:ext cx="281414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800" b="1" i="1" u="sng" dirty="0">
                <a:latin typeface="Arial" panose="020B0604020202020204" pitchFamily="34" charset="0"/>
                <a:cs typeface="Arial" panose="020B0604020202020204" pitchFamily="34" charset="0"/>
              </a:rPr>
              <a:t>Interface residues of </a:t>
            </a:r>
            <a:r>
              <a:rPr lang="en-IN" sz="800" b="1" i="1" u="sng" dirty="0" err="1">
                <a:latin typeface="Arial" panose="020B0604020202020204" pitchFamily="34" charset="0"/>
                <a:cs typeface="Arial" panose="020B0604020202020204" pitchFamily="34" charset="0"/>
              </a:rPr>
              <a:t>Piperine</a:t>
            </a:r>
            <a:r>
              <a:rPr lang="en-IN" sz="800" b="1" i="1" u="sng" dirty="0">
                <a:latin typeface="Arial" panose="020B0604020202020204" pitchFamily="34" charset="0"/>
                <a:cs typeface="Arial" panose="020B0604020202020204" pitchFamily="34" charset="0"/>
              </a:rPr>
              <a:t> (within 4Å) at ATP binding site on TKD</a:t>
            </a:r>
          </a:p>
          <a:p>
            <a:pPr algn="just"/>
            <a:r>
              <a:rPr lang="en-IN" sz="800" dirty="0">
                <a:latin typeface="Arial" panose="020B0604020202020204" pitchFamily="34" charset="0"/>
                <a:cs typeface="Arial" panose="020B0604020202020204" pitchFamily="34" charset="0"/>
              </a:rPr>
              <a:t>- H-bond interactions: None</a:t>
            </a:r>
          </a:p>
          <a:p>
            <a:pPr algn="just"/>
            <a:r>
              <a:rPr lang="en-IN" sz="800" dirty="0">
                <a:latin typeface="Arial" panose="020B0604020202020204" pitchFamily="34" charset="0"/>
                <a:cs typeface="Arial" panose="020B0604020202020204" pitchFamily="34" charset="0"/>
              </a:rPr>
              <a:t>- Non-contact interactions: GLY-841, ARG-842, ASN-923, V848, A866, K868, I888, L889, I892, V899, V914, V916, L1019, C1024, I1025, H1026, L1035, I1044, C1045, D1046, F1047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CA508A61-5017-005C-DE1F-395764CA98A7}"/>
              </a:ext>
            </a:extLst>
          </p:cNvPr>
          <p:cNvSpPr/>
          <p:nvPr/>
        </p:nvSpPr>
        <p:spPr>
          <a:xfrm>
            <a:off x="1976074" y="4709899"/>
            <a:ext cx="2880000" cy="252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48AD917-9512-5BF0-AA31-AD0380FED0F1}"/>
              </a:ext>
            </a:extLst>
          </p:cNvPr>
          <p:cNvSpPr txBox="1"/>
          <p:nvPr/>
        </p:nvSpPr>
        <p:spPr>
          <a:xfrm>
            <a:off x="2042639" y="6454991"/>
            <a:ext cx="18267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800" b="1" dirty="0">
                <a:latin typeface="Arial" panose="020B0604020202020204" pitchFamily="34" charset="0"/>
                <a:cs typeface="Arial" panose="020B0604020202020204" pitchFamily="34" charset="0"/>
              </a:rPr>
              <a:t>Binding affinity: -9.4kcal/mol</a:t>
            </a:r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3E6D4A66-C618-C9DC-8D56-57D39F8D1966}"/>
              </a:ext>
            </a:extLst>
          </p:cNvPr>
          <p:cNvSpPr/>
          <p:nvPr/>
        </p:nvSpPr>
        <p:spPr>
          <a:xfrm>
            <a:off x="3372059" y="5958589"/>
            <a:ext cx="295550" cy="288272"/>
          </a:xfrm>
          <a:prstGeom prst="ellipse">
            <a:avLst/>
          </a:prstGeom>
          <a:noFill/>
          <a:ln w="9525">
            <a:noFill/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sz="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F70CD241-CDAC-D18A-5C87-CC11925D4627}"/>
              </a:ext>
            </a:extLst>
          </p:cNvPr>
          <p:cNvSpPr/>
          <p:nvPr/>
        </p:nvSpPr>
        <p:spPr>
          <a:xfrm>
            <a:off x="3044423" y="6023317"/>
            <a:ext cx="181300" cy="197766"/>
          </a:xfrm>
          <a:prstGeom prst="ellipse">
            <a:avLst/>
          </a:prstGeom>
          <a:noFill/>
          <a:ln w="9525">
            <a:noFill/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sz="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07C2B5B3-6C2F-9CED-5B42-1914C1D3FDDB}"/>
              </a:ext>
            </a:extLst>
          </p:cNvPr>
          <p:cNvCxnSpPr>
            <a:cxnSpLocks/>
          </p:cNvCxnSpPr>
          <p:nvPr/>
        </p:nvCxnSpPr>
        <p:spPr>
          <a:xfrm>
            <a:off x="3216705" y="6189167"/>
            <a:ext cx="958740" cy="57694"/>
          </a:xfrm>
          <a:prstGeom prst="straightConnector1">
            <a:avLst/>
          </a:prstGeom>
          <a:ln w="6350">
            <a:noFill/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0B0A7494-8F60-E438-DDA7-3F79A03CCF90}"/>
              </a:ext>
            </a:extLst>
          </p:cNvPr>
          <p:cNvCxnSpPr>
            <a:cxnSpLocks/>
          </p:cNvCxnSpPr>
          <p:nvPr/>
        </p:nvCxnSpPr>
        <p:spPr>
          <a:xfrm flipV="1">
            <a:off x="3667609" y="5743686"/>
            <a:ext cx="550819" cy="288458"/>
          </a:xfrm>
          <a:prstGeom prst="straightConnector1">
            <a:avLst/>
          </a:prstGeom>
          <a:ln w="6350">
            <a:noFill/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Rectangle 43">
            <a:extLst>
              <a:ext uri="{FF2B5EF4-FFF2-40B4-BE49-F238E27FC236}">
                <a16:creationId xmlns:a16="http://schemas.microsoft.com/office/drawing/2014/main" id="{BA1D7237-2701-2BA2-1A99-A922C9520379}"/>
              </a:ext>
            </a:extLst>
          </p:cNvPr>
          <p:cNvSpPr/>
          <p:nvPr/>
        </p:nvSpPr>
        <p:spPr>
          <a:xfrm>
            <a:off x="2112311" y="4994175"/>
            <a:ext cx="2880000" cy="252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EBF8E868-E3AD-E2DA-7500-E8ED35DDDB08}"/>
              </a:ext>
            </a:extLst>
          </p:cNvPr>
          <p:cNvSpPr/>
          <p:nvPr/>
        </p:nvSpPr>
        <p:spPr>
          <a:xfrm>
            <a:off x="1979740" y="4673907"/>
            <a:ext cx="2880000" cy="284026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49B16A67-ABE6-D80B-D441-B83D65A01115}"/>
              </a:ext>
            </a:extLst>
          </p:cNvPr>
          <p:cNvSpPr txBox="1"/>
          <p:nvPr/>
        </p:nvSpPr>
        <p:spPr>
          <a:xfrm>
            <a:off x="2125942" y="613613"/>
            <a:ext cx="2472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Piperine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(PPR)</a:t>
            </a:r>
            <a:endParaRPr lang="en-I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4A66A9E8-8F3B-9634-2A93-75BE04599BF8}"/>
              </a:ext>
            </a:extLst>
          </p:cNvPr>
          <p:cNvSpPr txBox="1"/>
          <p:nvPr/>
        </p:nvSpPr>
        <p:spPr>
          <a:xfrm>
            <a:off x="1324518" y="4332996"/>
            <a:ext cx="4160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61C98536-661B-16B1-4B74-291AB160B67A}"/>
              </a:ext>
            </a:extLst>
          </p:cNvPr>
          <p:cNvSpPr txBox="1"/>
          <p:nvPr/>
        </p:nvSpPr>
        <p:spPr>
          <a:xfrm>
            <a:off x="598375" y="7828547"/>
            <a:ext cx="578317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4: </a:t>
            </a:r>
            <a:r>
              <a:rPr lang="en-US" sz="1200" b="1" i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silico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valuation of </a:t>
            </a:r>
            <a:r>
              <a:rPr lang="en-US" sz="12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PR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or GBM therapeutics. (A)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D chemical structure drawn using 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emDraw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ith BBB permeability probability score;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B)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ocked pose of </a:t>
            </a:r>
            <a:r>
              <a:rPr lang="en-US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PR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ith VEGFR-2 TKD domain and interacting residues. Tools: BBB permeability by 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metSAR</a:t>
            </a:r>
            <a:r>
              <a:rPr lang="en-US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US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hlinkClick r:id="rId3"/>
              </a:rPr>
              <a:t>http://lmmd.ecust.edu.cn/admetsar1/</a:t>
            </a:r>
            <a:r>
              <a:rPr lang="en-US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molecular docking UCSF Chimera 1.15. Image: 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yMol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436253E5-09B3-E0F5-8112-8BFD962E5D2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41277386"/>
              </p:ext>
            </p:extLst>
          </p:nvPr>
        </p:nvGraphicFramePr>
        <p:xfrm>
          <a:off x="1981014" y="1747612"/>
          <a:ext cx="2808000" cy="901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3945530" imgH="1252775" progId="ChemDraw.Document.6.0">
                  <p:embed/>
                </p:oleObj>
              </mc:Choice>
              <mc:Fallback>
                <p:oleObj r:id="rId4" imgW="3945530" imgH="1252775" progId="ChemDraw.Document.6.0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BD464548-6677-1EE0-D7E4-68DFC5C3FA3D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981014" y="1747612"/>
                        <a:ext cx="2808000" cy="901213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8CD0DCB8-2B36-3703-8A8E-0AD3010D976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28711"/>
          <a:stretch/>
        </p:blipFill>
        <p:spPr>
          <a:xfrm>
            <a:off x="2380776" y="4741976"/>
            <a:ext cx="2160000" cy="1731369"/>
          </a:xfrm>
          <a:prstGeom prst="rect">
            <a:avLst/>
          </a:prstGeom>
          <a:ln>
            <a:noFill/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1B0AF53-BE46-ED90-5361-851A4F30DF90}"/>
              </a:ext>
            </a:extLst>
          </p:cNvPr>
          <p:cNvSpPr txBox="1"/>
          <p:nvPr/>
        </p:nvSpPr>
        <p:spPr>
          <a:xfrm>
            <a:off x="6241772" y="7950"/>
            <a:ext cx="5963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F4</a:t>
            </a:r>
            <a:endParaRPr lang="en-I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38881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17</TotalTime>
  <Words>531</Words>
  <Application>Microsoft Office PowerPoint</Application>
  <PresentationFormat>A4 Paper (210x297 mm)</PresentationFormat>
  <Paragraphs>46</Paragraphs>
  <Slides>4</Slides>
  <Notes>4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ChemDraw.Document.6.0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 Senrung</dc:creator>
  <cp:lastModifiedBy>Anna Senrung</cp:lastModifiedBy>
  <cp:revision>37</cp:revision>
  <dcterms:created xsi:type="dcterms:W3CDTF">2023-06-02T03:03:31Z</dcterms:created>
  <dcterms:modified xsi:type="dcterms:W3CDTF">2023-06-04T17:12:56Z</dcterms:modified>
</cp:coreProperties>
</file>